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77" d="100"/>
          <a:sy n="77" d="100"/>
        </p:scale>
        <p:origin x="134" y="-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8A0CE853-DA70-425E-AAFF-C67208826DD0}"/>
    <pc:docChg chg="custSel modSld">
      <pc:chgData name="Laycock, Joseph" userId="c4bfcbf4-3ccc-440e-b317-559baf184f0d" providerId="ADAL" clId="{8A0CE853-DA70-425E-AAFF-C67208826DD0}" dt="2024-02-15T16:20:44.553" v="63" actId="1036"/>
      <pc:docMkLst>
        <pc:docMk/>
      </pc:docMkLst>
      <pc:sldChg chg="delSp modSp mod">
        <pc:chgData name="Laycock, Joseph" userId="c4bfcbf4-3ccc-440e-b317-559baf184f0d" providerId="ADAL" clId="{8A0CE853-DA70-425E-AAFF-C67208826DD0}" dt="2024-02-15T16:20:44.553" v="63" actId="1036"/>
        <pc:sldMkLst>
          <pc:docMk/>
          <pc:sldMk cId="2867428870" sldId="268"/>
        </pc:sldMkLst>
        <pc:spChg chg="mod">
          <ac:chgData name="Laycock, Joseph" userId="c4bfcbf4-3ccc-440e-b317-559baf184f0d" providerId="ADAL" clId="{8A0CE853-DA70-425E-AAFF-C67208826DD0}" dt="2024-02-15T16:18:19.570" v="17" actId="14100"/>
          <ac:spMkLst>
            <pc:docMk/>
            <pc:sldMk cId="2867428870" sldId="268"/>
            <ac:spMk id="30" creationId="{A98738AB-CF3D-114E-CA37-7C50AD2C5F8E}"/>
          </ac:spMkLst>
        </pc:spChg>
        <pc:spChg chg="mod">
          <ac:chgData name="Laycock, Joseph" userId="c4bfcbf4-3ccc-440e-b317-559baf184f0d" providerId="ADAL" clId="{8A0CE853-DA70-425E-AAFF-C67208826DD0}" dt="2024-02-15T16:20:11.510" v="49" actId="255"/>
          <ac:spMkLst>
            <pc:docMk/>
            <pc:sldMk cId="2867428870" sldId="268"/>
            <ac:spMk id="35" creationId="{D2BA3DF2-B8C2-247D-9DB5-71772C10C50C}"/>
          </ac:spMkLst>
        </pc:spChg>
        <pc:spChg chg="mod">
          <ac:chgData name="Laycock, Joseph" userId="c4bfcbf4-3ccc-440e-b317-559baf184f0d" providerId="ADAL" clId="{8A0CE853-DA70-425E-AAFF-C67208826DD0}" dt="2024-02-15T16:20:24.986" v="53" actId="255"/>
          <ac:spMkLst>
            <pc:docMk/>
            <pc:sldMk cId="2867428870" sldId="268"/>
            <ac:spMk id="37" creationId="{30FAC63D-9A9A-0019-671D-96B6F4B1E815}"/>
          </ac:spMkLst>
        </pc:spChg>
        <pc:spChg chg="mod">
          <ac:chgData name="Laycock, Joseph" userId="c4bfcbf4-3ccc-440e-b317-559baf184f0d" providerId="ADAL" clId="{8A0CE853-DA70-425E-AAFF-C67208826DD0}" dt="2024-02-15T16:20:19.531" v="52" actId="255"/>
          <ac:spMkLst>
            <pc:docMk/>
            <pc:sldMk cId="2867428870" sldId="268"/>
            <ac:spMk id="38" creationId="{6F030DD7-1DFE-4D1B-E877-03CFEE5DBA98}"/>
          </ac:spMkLst>
        </pc:spChg>
        <pc:spChg chg="mod">
          <ac:chgData name="Laycock, Joseph" userId="c4bfcbf4-3ccc-440e-b317-559baf184f0d" providerId="ADAL" clId="{8A0CE853-DA70-425E-AAFF-C67208826DD0}" dt="2024-02-15T16:18:07.530" v="16" actId="14100"/>
          <ac:spMkLst>
            <pc:docMk/>
            <pc:sldMk cId="2867428870" sldId="268"/>
            <ac:spMk id="40" creationId="{858EB4D2-41F3-A00B-229A-49B67F6D496C}"/>
          </ac:spMkLst>
        </pc:spChg>
        <pc:spChg chg="del mod">
          <ac:chgData name="Laycock, Joseph" userId="c4bfcbf4-3ccc-440e-b317-559baf184f0d" providerId="ADAL" clId="{8A0CE853-DA70-425E-AAFF-C67208826DD0}" dt="2024-02-15T16:18:38.905" v="30" actId="478"/>
          <ac:spMkLst>
            <pc:docMk/>
            <pc:sldMk cId="2867428870" sldId="268"/>
            <ac:spMk id="41" creationId="{04ED1602-FD7C-42B2-4C40-12B90EBE2C0D}"/>
          </ac:spMkLst>
        </pc:spChg>
        <pc:spChg chg="mod">
          <ac:chgData name="Laycock, Joseph" userId="c4bfcbf4-3ccc-440e-b317-559baf184f0d" providerId="ADAL" clId="{8A0CE853-DA70-425E-AAFF-C67208826DD0}" dt="2024-02-15T16:19:53.725" v="46" actId="255"/>
          <ac:spMkLst>
            <pc:docMk/>
            <pc:sldMk cId="2867428870" sldId="268"/>
            <ac:spMk id="42" creationId="{15F46EB3-9AEC-FD8A-BD13-FD4DF2E73421}"/>
          </ac:spMkLst>
        </pc:spChg>
        <pc:spChg chg="mod">
          <ac:chgData name="Laycock, Joseph" userId="c4bfcbf4-3ccc-440e-b317-559baf184f0d" providerId="ADAL" clId="{8A0CE853-DA70-425E-AAFF-C67208826DD0}" dt="2024-02-15T16:18:45.050" v="31" actId="2085"/>
          <ac:spMkLst>
            <pc:docMk/>
            <pc:sldMk cId="2867428870" sldId="268"/>
            <ac:spMk id="43" creationId="{D2158681-1F58-4860-13CB-E4BBCE67D0C8}"/>
          </ac:spMkLst>
        </pc:spChg>
        <pc:spChg chg="mod">
          <ac:chgData name="Laycock, Joseph" userId="c4bfcbf4-3ccc-440e-b317-559baf184f0d" providerId="ADAL" clId="{8A0CE853-DA70-425E-AAFF-C67208826DD0}" dt="2024-02-15T16:20:44.553" v="63" actId="1036"/>
          <ac:spMkLst>
            <pc:docMk/>
            <pc:sldMk cId="2867428870" sldId="268"/>
            <ac:spMk id="44" creationId="{9F1BADD6-E920-BF80-957D-716412784CAE}"/>
          </ac:spMkLst>
        </pc:spChg>
        <pc:spChg chg="mod">
          <ac:chgData name="Laycock, Joseph" userId="c4bfcbf4-3ccc-440e-b317-559baf184f0d" providerId="ADAL" clId="{8A0CE853-DA70-425E-AAFF-C67208826DD0}" dt="2024-02-15T16:20:44.553" v="63" actId="1036"/>
          <ac:spMkLst>
            <pc:docMk/>
            <pc:sldMk cId="2867428870" sldId="268"/>
            <ac:spMk id="45" creationId="{5E3247CE-F464-FEBD-2155-1752B20C3F34}"/>
          </ac:spMkLst>
        </pc:spChg>
        <pc:spChg chg="mod">
          <ac:chgData name="Laycock, Joseph" userId="c4bfcbf4-3ccc-440e-b317-559baf184f0d" providerId="ADAL" clId="{8A0CE853-DA70-425E-AAFF-C67208826DD0}" dt="2024-02-15T16:18:51.810" v="33" actId="2085"/>
          <ac:spMkLst>
            <pc:docMk/>
            <pc:sldMk cId="2867428870" sldId="268"/>
            <ac:spMk id="46" creationId="{4CA59ADF-AE64-D4E2-D4CC-C447B1F4252E}"/>
          </ac:spMkLst>
        </pc:spChg>
        <pc:spChg chg="mod">
          <ac:chgData name="Laycock, Joseph" userId="c4bfcbf4-3ccc-440e-b317-559baf184f0d" providerId="ADAL" clId="{8A0CE853-DA70-425E-AAFF-C67208826DD0}" dt="2024-02-15T16:19:58.410" v="47" actId="255"/>
          <ac:spMkLst>
            <pc:docMk/>
            <pc:sldMk cId="2867428870" sldId="268"/>
            <ac:spMk id="47" creationId="{C00032B2-C8D9-8761-B345-1F4BADC3FDC7}"/>
          </ac:spMkLst>
        </pc:spChg>
        <pc:spChg chg="mod">
          <ac:chgData name="Laycock, Joseph" userId="c4bfcbf4-3ccc-440e-b317-559baf184f0d" providerId="ADAL" clId="{8A0CE853-DA70-425E-AAFF-C67208826DD0}" dt="2024-02-15T16:19:10.135" v="45" actId="1038"/>
          <ac:spMkLst>
            <pc:docMk/>
            <pc:sldMk cId="2867428870" sldId="268"/>
            <ac:spMk id="52" creationId="{71F20927-0EBC-0E96-63AB-5156CB3514F1}"/>
          </ac:spMkLst>
        </pc:spChg>
        <pc:grpChg chg="mod">
          <ac:chgData name="Laycock, Joseph" userId="c4bfcbf4-3ccc-440e-b317-559baf184f0d" providerId="ADAL" clId="{8A0CE853-DA70-425E-AAFF-C67208826DD0}" dt="2024-02-15T16:17:54.151" v="10" actId="1076"/>
          <ac:grpSpMkLst>
            <pc:docMk/>
            <pc:sldMk cId="2867428870" sldId="268"/>
            <ac:grpSpMk id="10" creationId="{4589DF0C-F10E-3658-4CBA-B57D45B92E40}"/>
          </ac:grpSpMkLst>
        </pc:grpChg>
        <pc:grpChg chg="mod">
          <ac:chgData name="Laycock, Joseph" userId="c4bfcbf4-3ccc-440e-b317-559baf184f0d" providerId="ADAL" clId="{8A0CE853-DA70-425E-AAFF-C67208826DD0}" dt="2024-02-15T16:17:45.430" v="8" actId="1076"/>
          <ac:grpSpMkLst>
            <pc:docMk/>
            <pc:sldMk cId="2867428870" sldId="268"/>
            <ac:grpSpMk id="27" creationId="{9EDCF9ED-F7B6-48A3-B714-BF795DA0DB37}"/>
          </ac:grpSpMkLst>
        </pc:grpChg>
        <pc:grpChg chg="mod">
          <ac:chgData name="Laycock, Joseph" userId="c4bfcbf4-3ccc-440e-b317-559baf184f0d" providerId="ADAL" clId="{8A0CE853-DA70-425E-AAFF-C67208826DD0}" dt="2024-02-15T16:20:39.661" v="60" actId="1036"/>
          <ac:grpSpMkLst>
            <pc:docMk/>
            <pc:sldMk cId="2867428870" sldId="268"/>
            <ac:grpSpMk id="32" creationId="{DCEA0DAA-E791-8486-3B83-D8747EF30ADB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itial lactate levels linked to oliguria in term neonates with </a:t>
            </a:r>
            <a:br>
              <a:rPr lang="en-US" sz="2800" b="1" dirty="0">
                <a:solidFill>
                  <a:schemeClr val="bg1"/>
                </a:solidFill>
              </a:rPr>
            </a:br>
            <a:r>
              <a:rPr lang="en-US" sz="2800" b="1" dirty="0">
                <a:solidFill>
                  <a:schemeClr val="bg1"/>
                </a:solidFill>
              </a:rPr>
              <a:t>perinatal asphyxia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8B6892-1648-DF62-E831-66BF54B0FEA3}"/>
              </a:ext>
            </a:extLst>
          </p:cNvPr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arly elevated lactate level in peripheral artery gas are </a:t>
            </a:r>
            <a:r>
              <a:rPr lang="en-US" altLang="zh-CN" dirty="0">
                <a:solidFill>
                  <a:schemeClr val="bg1"/>
                </a:solidFill>
              </a:rPr>
              <a:t>associated with </a:t>
            </a:r>
            <a:r>
              <a:rPr lang="en-US" dirty="0">
                <a:solidFill>
                  <a:schemeClr val="bg1"/>
                </a:solidFill>
              </a:rPr>
              <a:t>oliguria during the first 24 h after birth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C6002-7C3F-D901-2E37-E725207AAA1E}"/>
              </a:ext>
            </a:extLst>
          </p:cNvPr>
          <p:cNvSpPr txBox="1"/>
          <p:nvPr/>
        </p:nvSpPr>
        <p:spPr>
          <a:xfrm>
            <a:off x="7650039" y="568686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Zhang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8B74F-E6D1-9E52-9D66-BB2127F9D94A}"/>
              </a:ext>
            </a:extLst>
          </p:cNvPr>
          <p:cNvSpPr txBox="1"/>
          <p:nvPr/>
        </p:nvSpPr>
        <p:spPr>
          <a:xfrm>
            <a:off x="115919" y="5743041"/>
            <a:ext cx="73619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areful monitoring should be performed on the urination status of term infants with a lactate value of 8.15 mmol/L or greater after asphyxia resuscitation, especially those with a history of intrauterine distress or severe asphyxia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2B239D-CEFC-8FA7-D021-3C9175EC1A80}"/>
              </a:ext>
            </a:extLst>
          </p:cNvPr>
          <p:cNvSpPr txBox="1"/>
          <p:nvPr/>
        </p:nvSpPr>
        <p:spPr>
          <a:xfrm>
            <a:off x="637955" y="2689462"/>
            <a:ext cx="17304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altLang="zh-CN" dirty="0">
                <a:solidFill>
                  <a:srgbClr val="0065AA"/>
                </a:solidFill>
              </a:rPr>
              <a:t>127 asphyxiated term neonates in oliguria group</a:t>
            </a:r>
          </a:p>
        </p:txBody>
      </p:sp>
      <p:sp>
        <p:nvSpPr>
          <p:cNvPr id="7" name="Rectangle 3">
            <a:extLst>
              <a:ext uri="{FF2B5EF4-FFF2-40B4-BE49-F238E27FC236}">
                <a16:creationId xmlns:a16="http://schemas.microsoft.com/office/drawing/2014/main" id="{949535EF-8327-BE3F-7EC9-5C69F50C7B63}"/>
              </a:ext>
            </a:extLst>
          </p:cNvPr>
          <p:cNvSpPr/>
          <p:nvPr/>
        </p:nvSpPr>
        <p:spPr>
          <a:xfrm>
            <a:off x="2361551" y="3131437"/>
            <a:ext cx="2324569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700" dirty="0"/>
              <a:t> Urination during the </a:t>
            </a:r>
            <a:br>
              <a:rPr lang="en-US" altLang="zh-CN" sz="1700" dirty="0"/>
            </a:br>
            <a:r>
              <a:rPr lang="en-US" altLang="zh-CN" sz="1700" dirty="0"/>
              <a:t>first 24 h of life</a:t>
            </a:r>
            <a:endParaRPr lang="en-GB" sz="1700" dirty="0"/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F9E2B56D-3FBA-3C4E-EF03-092E63751202}"/>
              </a:ext>
            </a:extLst>
          </p:cNvPr>
          <p:cNvSpPr/>
          <p:nvPr/>
        </p:nvSpPr>
        <p:spPr>
          <a:xfrm>
            <a:off x="2361551" y="1927408"/>
            <a:ext cx="2324569" cy="1114600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700" dirty="0">
                <a:effectLst/>
                <a:ea typeface="宋体" panose="02010600030101010101" pitchFamily="2" charset="-122"/>
              </a:rPr>
              <a:t>Peripheral arterial blood gas characteristics immediately after resuscitation</a:t>
            </a:r>
            <a:endParaRPr lang="en-GB" sz="1700" dirty="0"/>
          </a:p>
        </p:txBody>
      </p:sp>
      <p:sp>
        <p:nvSpPr>
          <p:cNvPr id="9" name="矩形 3">
            <a:extLst>
              <a:ext uri="{FF2B5EF4-FFF2-40B4-BE49-F238E27FC236}">
                <a16:creationId xmlns:a16="http://schemas.microsoft.com/office/drawing/2014/main" id="{E60BB9B2-75C7-C600-9BC6-AB34876E16AE}"/>
              </a:ext>
            </a:extLst>
          </p:cNvPr>
          <p:cNvSpPr/>
          <p:nvPr/>
        </p:nvSpPr>
        <p:spPr>
          <a:xfrm>
            <a:off x="514806" y="4381049"/>
            <a:ext cx="193230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altLang="zh-CN" dirty="0">
                <a:solidFill>
                  <a:srgbClr val="0065AA"/>
                </a:solidFill>
              </a:rPr>
              <a:t>166 asphyxiated term neonates in control group</a:t>
            </a:r>
          </a:p>
        </p:txBody>
      </p:sp>
      <p:grpSp>
        <p:nvGrpSpPr>
          <p:cNvPr id="10" name="组合 21">
            <a:extLst>
              <a:ext uri="{FF2B5EF4-FFF2-40B4-BE49-F238E27FC236}">
                <a16:creationId xmlns:a16="http://schemas.microsoft.com/office/drawing/2014/main" id="{4589DF0C-F10E-3658-4CBA-B57D45B92E40}"/>
              </a:ext>
            </a:extLst>
          </p:cNvPr>
          <p:cNvGrpSpPr/>
          <p:nvPr/>
        </p:nvGrpSpPr>
        <p:grpSpPr>
          <a:xfrm>
            <a:off x="145091" y="2517980"/>
            <a:ext cx="576446" cy="902224"/>
            <a:chOff x="277541" y="2251191"/>
            <a:chExt cx="640852" cy="1003029"/>
          </a:xfrm>
        </p:grpSpPr>
        <p:sp>
          <p:nvSpPr>
            <p:cNvPr id="25" name="Freeform: Shape 46">
              <a:extLst>
                <a:ext uri="{FF2B5EF4-FFF2-40B4-BE49-F238E27FC236}">
                  <a16:creationId xmlns:a16="http://schemas.microsoft.com/office/drawing/2014/main" id="{025D85E4-612D-21D9-FA85-1725F0CD3B93}"/>
                </a:ext>
              </a:extLst>
            </p:cNvPr>
            <p:cNvSpPr/>
            <p:nvPr/>
          </p:nvSpPr>
          <p:spPr>
            <a:xfrm>
              <a:off x="277541" y="2251191"/>
              <a:ext cx="513284" cy="982104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26" name="Freeform: Shape 46">
              <a:extLst>
                <a:ext uri="{FF2B5EF4-FFF2-40B4-BE49-F238E27FC236}">
                  <a16:creationId xmlns:a16="http://schemas.microsoft.com/office/drawing/2014/main" id="{A1AA3B39-081D-6242-BF36-DBF44CEB5AE9}"/>
                </a:ext>
              </a:extLst>
            </p:cNvPr>
            <p:cNvSpPr/>
            <p:nvPr/>
          </p:nvSpPr>
          <p:spPr>
            <a:xfrm>
              <a:off x="405109" y="2272116"/>
              <a:ext cx="513284" cy="982104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grpSp>
        <p:nvGrpSpPr>
          <p:cNvPr id="27" name="组合 22">
            <a:extLst>
              <a:ext uri="{FF2B5EF4-FFF2-40B4-BE49-F238E27FC236}">
                <a16:creationId xmlns:a16="http://schemas.microsoft.com/office/drawing/2014/main" id="{9EDCF9ED-F7B6-48A3-B714-BF795DA0DB37}"/>
              </a:ext>
            </a:extLst>
          </p:cNvPr>
          <p:cNvGrpSpPr/>
          <p:nvPr/>
        </p:nvGrpSpPr>
        <p:grpSpPr>
          <a:xfrm>
            <a:off x="115919" y="4189342"/>
            <a:ext cx="549305" cy="923330"/>
            <a:chOff x="317897" y="3837148"/>
            <a:chExt cx="622813" cy="1116935"/>
          </a:xfrm>
        </p:grpSpPr>
        <p:sp>
          <p:nvSpPr>
            <p:cNvPr id="28" name="Freeform: Shape 46">
              <a:extLst>
                <a:ext uri="{FF2B5EF4-FFF2-40B4-BE49-F238E27FC236}">
                  <a16:creationId xmlns:a16="http://schemas.microsoft.com/office/drawing/2014/main" id="{7DAB9B93-9F69-7D1E-B55D-9352ED4A281B}"/>
                </a:ext>
              </a:extLst>
            </p:cNvPr>
            <p:cNvSpPr/>
            <p:nvPr/>
          </p:nvSpPr>
          <p:spPr>
            <a:xfrm>
              <a:off x="317897" y="3837148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29" name="Freeform: Shape 46">
              <a:extLst>
                <a:ext uri="{FF2B5EF4-FFF2-40B4-BE49-F238E27FC236}">
                  <a16:creationId xmlns:a16="http://schemas.microsoft.com/office/drawing/2014/main" id="{D6706A0F-8A2A-FC39-8BAE-BE52BDDC8807}"/>
                </a:ext>
              </a:extLst>
            </p:cNvPr>
            <p:cNvSpPr/>
            <p:nvPr/>
          </p:nvSpPr>
          <p:spPr>
            <a:xfrm>
              <a:off x="427426" y="3904185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30" name="Rectangle 19">
            <a:extLst>
              <a:ext uri="{FF2B5EF4-FFF2-40B4-BE49-F238E27FC236}">
                <a16:creationId xmlns:a16="http://schemas.microsoft.com/office/drawing/2014/main" id="{A98738AB-CF3D-114E-CA37-7C50AD2C5F8E}"/>
              </a:ext>
            </a:extLst>
          </p:cNvPr>
          <p:cNvSpPr/>
          <p:nvPr/>
        </p:nvSpPr>
        <p:spPr>
          <a:xfrm>
            <a:off x="2348569" y="3818539"/>
            <a:ext cx="2347488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700" dirty="0">
                <a:effectLst/>
                <a:ea typeface="宋体" panose="02010600030101010101" pitchFamily="2" charset="-122"/>
              </a:rPr>
              <a:t>Early risk factors for oliguria</a:t>
            </a:r>
            <a:endParaRPr lang="en-GB" sz="1700" dirty="0"/>
          </a:p>
        </p:txBody>
      </p:sp>
      <p:cxnSp>
        <p:nvCxnSpPr>
          <p:cNvPr id="31" name="Straight Arrow Connector 13">
            <a:extLst>
              <a:ext uri="{FF2B5EF4-FFF2-40B4-BE49-F238E27FC236}">
                <a16:creationId xmlns:a16="http://schemas.microsoft.com/office/drawing/2014/main" id="{719007F8-2EFD-58C0-7E52-C2DC2EA66BFA}"/>
              </a:ext>
            </a:extLst>
          </p:cNvPr>
          <p:cNvCxnSpPr/>
          <p:nvPr/>
        </p:nvCxnSpPr>
        <p:spPr>
          <a:xfrm flipV="1">
            <a:off x="1299718" y="3980078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" name="组合 47">
            <a:extLst>
              <a:ext uri="{FF2B5EF4-FFF2-40B4-BE49-F238E27FC236}">
                <a16:creationId xmlns:a16="http://schemas.microsoft.com/office/drawing/2014/main" id="{DCEA0DAA-E791-8486-3B83-D8747EF30ADB}"/>
              </a:ext>
            </a:extLst>
          </p:cNvPr>
          <p:cNvGrpSpPr/>
          <p:nvPr/>
        </p:nvGrpSpPr>
        <p:grpSpPr>
          <a:xfrm>
            <a:off x="5077624" y="1984220"/>
            <a:ext cx="6452281" cy="988228"/>
            <a:chOff x="5268139" y="1865383"/>
            <a:chExt cx="6452281" cy="988228"/>
          </a:xfrm>
        </p:grpSpPr>
        <p:sp>
          <p:nvSpPr>
            <p:cNvPr id="33" name="Up Arrow 69">
              <a:extLst>
                <a:ext uri="{FF2B5EF4-FFF2-40B4-BE49-F238E27FC236}">
                  <a16:creationId xmlns:a16="http://schemas.microsoft.com/office/drawing/2014/main" id="{DCC95FC1-A363-93C2-EA5E-B4D1AF23ABA8}"/>
                </a:ext>
              </a:extLst>
            </p:cNvPr>
            <p:cNvSpPr/>
            <p:nvPr/>
          </p:nvSpPr>
          <p:spPr>
            <a:xfrm>
              <a:off x="5268139" y="1880998"/>
              <a:ext cx="301374" cy="476776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65AA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4" name="Up Arrow 69">
              <a:extLst>
                <a:ext uri="{FF2B5EF4-FFF2-40B4-BE49-F238E27FC236}">
                  <a16:creationId xmlns:a16="http://schemas.microsoft.com/office/drawing/2014/main" id="{F629F48A-C384-FBD4-2661-BAF55EA844AC}"/>
                </a:ext>
              </a:extLst>
            </p:cNvPr>
            <p:cNvSpPr/>
            <p:nvPr/>
          </p:nvSpPr>
          <p:spPr>
            <a:xfrm rot="10800000">
              <a:off x="5276163" y="2376835"/>
              <a:ext cx="301374" cy="476776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65AA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5" name="矩形 4">
              <a:extLst>
                <a:ext uri="{FF2B5EF4-FFF2-40B4-BE49-F238E27FC236}">
                  <a16:creationId xmlns:a16="http://schemas.microsoft.com/office/drawing/2014/main" id="{D2BA3DF2-B8C2-247D-9DB5-71772C10C50C}"/>
                </a:ext>
              </a:extLst>
            </p:cNvPr>
            <p:cNvSpPr/>
            <p:nvPr/>
          </p:nvSpPr>
          <p:spPr>
            <a:xfrm>
              <a:off x="5751958" y="1865383"/>
              <a:ext cx="5941584" cy="3539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700" dirty="0">
                  <a:solidFill>
                    <a:srgbClr val="0065AA"/>
                  </a:solidFill>
                </a:rPr>
                <a:t>higher lactate levels</a:t>
              </a:r>
            </a:p>
          </p:txBody>
        </p:sp>
        <p:sp>
          <p:nvSpPr>
            <p:cNvPr id="36" name="矩形 5">
              <a:extLst>
                <a:ext uri="{FF2B5EF4-FFF2-40B4-BE49-F238E27FC236}">
                  <a16:creationId xmlns:a16="http://schemas.microsoft.com/office/drawing/2014/main" id="{08EE7B83-46EE-2EB2-2A0E-F009690A34E1}"/>
                </a:ext>
              </a:extLst>
            </p:cNvPr>
            <p:cNvSpPr/>
            <p:nvPr/>
          </p:nvSpPr>
          <p:spPr>
            <a:xfrm>
              <a:off x="5751958" y="2144903"/>
              <a:ext cx="451197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zh-CN" altLang="en-US" dirty="0">
                <a:solidFill>
                  <a:srgbClr val="0065AA"/>
                </a:solidFill>
              </a:endParaRPr>
            </a:p>
          </p:txBody>
        </p:sp>
        <p:sp>
          <p:nvSpPr>
            <p:cNvPr id="37" name="矩形 6">
              <a:extLst>
                <a:ext uri="{FF2B5EF4-FFF2-40B4-BE49-F238E27FC236}">
                  <a16:creationId xmlns:a16="http://schemas.microsoft.com/office/drawing/2014/main" id="{30FAC63D-9A9A-0019-671D-96B6F4B1E815}"/>
                </a:ext>
              </a:extLst>
            </p:cNvPr>
            <p:cNvSpPr/>
            <p:nvPr/>
          </p:nvSpPr>
          <p:spPr>
            <a:xfrm>
              <a:off x="5778836" y="2483520"/>
              <a:ext cx="5941584" cy="3539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700" dirty="0">
                  <a:solidFill>
                    <a:srgbClr val="0065AA"/>
                  </a:solidFill>
                </a:rPr>
                <a:t>Lower PCO</a:t>
              </a:r>
              <a:r>
                <a:rPr lang="en-US" altLang="zh-CN" sz="1700" baseline="-25000" dirty="0">
                  <a:solidFill>
                    <a:srgbClr val="0065AA"/>
                  </a:solidFill>
                </a:rPr>
                <a:t>2</a:t>
              </a:r>
              <a:r>
                <a:rPr lang="en-US" altLang="zh-CN" sz="1700" dirty="0">
                  <a:solidFill>
                    <a:srgbClr val="0065AA"/>
                  </a:solidFill>
                </a:rPr>
                <a:t>, BE, HCO</a:t>
              </a:r>
              <a:r>
                <a:rPr lang="en-US" altLang="zh-CN" sz="1700" baseline="-25000" dirty="0">
                  <a:solidFill>
                    <a:srgbClr val="0065AA"/>
                  </a:solidFill>
                </a:rPr>
                <a:t>3</a:t>
              </a:r>
              <a:r>
                <a:rPr lang="en-US" altLang="zh-CN" sz="1700" dirty="0">
                  <a:solidFill>
                    <a:srgbClr val="0065AA"/>
                  </a:solidFill>
                </a:rPr>
                <a:t> </a:t>
              </a:r>
              <a:endParaRPr lang="zh-CN" altLang="en-US" sz="1700" dirty="0">
                <a:solidFill>
                  <a:srgbClr val="0065AA"/>
                </a:solidFill>
              </a:endParaRPr>
            </a:p>
          </p:txBody>
        </p:sp>
        <p:sp>
          <p:nvSpPr>
            <p:cNvPr id="38" name="矩形 1">
              <a:extLst>
                <a:ext uri="{FF2B5EF4-FFF2-40B4-BE49-F238E27FC236}">
                  <a16:creationId xmlns:a16="http://schemas.microsoft.com/office/drawing/2014/main" id="{6F030DD7-1DFE-4D1B-E877-03CFEE5DBA98}"/>
                </a:ext>
              </a:extLst>
            </p:cNvPr>
            <p:cNvSpPr/>
            <p:nvPr/>
          </p:nvSpPr>
          <p:spPr>
            <a:xfrm>
              <a:off x="5755036" y="2191902"/>
              <a:ext cx="918841" cy="3539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700" dirty="0">
                  <a:solidFill>
                    <a:srgbClr val="0065AA"/>
                  </a:solidFill>
                </a:rPr>
                <a:t>pH, PO</a:t>
              </a:r>
              <a:r>
                <a:rPr lang="en-US" altLang="zh-CN" sz="1700" baseline="-25000" dirty="0">
                  <a:solidFill>
                    <a:srgbClr val="0065AA"/>
                  </a:solidFill>
                </a:rPr>
                <a:t>2</a:t>
              </a:r>
              <a:r>
                <a:rPr lang="zh-CN" altLang="en-US" sz="1700" dirty="0">
                  <a:solidFill>
                    <a:srgbClr val="0065AA"/>
                  </a:solidFill>
                </a:rPr>
                <a:t> </a:t>
              </a:r>
            </a:p>
          </p:txBody>
        </p:sp>
        <p:sp>
          <p:nvSpPr>
            <p:cNvPr id="39" name="Rectangle 6">
              <a:extLst>
                <a:ext uri="{FF2B5EF4-FFF2-40B4-BE49-F238E27FC236}">
                  <a16:creationId xmlns:a16="http://schemas.microsoft.com/office/drawing/2014/main" id="{6C9D798B-0F12-5F2F-B866-621F59FD9112}"/>
                </a:ext>
              </a:extLst>
            </p:cNvPr>
            <p:cNvSpPr/>
            <p:nvPr/>
          </p:nvSpPr>
          <p:spPr>
            <a:xfrm flipV="1">
              <a:off x="5277028" y="2324105"/>
              <a:ext cx="290327" cy="86516"/>
            </a:xfrm>
            <a:prstGeom prst="rect">
              <a:avLst/>
            </a:prstGeom>
            <a:solidFill>
              <a:srgbClr val="65AA00"/>
            </a:solidFill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40" name="Rectangle 55">
            <a:extLst>
              <a:ext uri="{FF2B5EF4-FFF2-40B4-BE49-F238E27FC236}">
                <a16:creationId xmlns:a16="http://schemas.microsoft.com/office/drawing/2014/main" id="{858EB4D2-41F3-A00B-229A-49B67F6D496C}"/>
              </a:ext>
            </a:extLst>
          </p:cNvPr>
          <p:cNvSpPr/>
          <p:nvPr/>
        </p:nvSpPr>
        <p:spPr>
          <a:xfrm>
            <a:off x="2348570" y="4480235"/>
            <a:ext cx="2347488" cy="1081144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700" dirty="0">
                <a:effectLst/>
                <a:ea typeface="宋体" panose="02010600030101010101" pitchFamily="2" charset="-122"/>
              </a:rPr>
              <a:t>The evaluation potential of the lactate level in blood gas for oliguria</a:t>
            </a:r>
            <a:endParaRPr lang="en-GB" sz="1700" dirty="0"/>
          </a:p>
        </p:txBody>
      </p:sp>
      <p:sp>
        <p:nvSpPr>
          <p:cNvPr id="42" name="文本框 10">
            <a:extLst>
              <a:ext uri="{FF2B5EF4-FFF2-40B4-BE49-F238E27FC236}">
                <a16:creationId xmlns:a16="http://schemas.microsoft.com/office/drawing/2014/main" id="{15F46EB3-9AEC-FD8A-BD13-FD4DF2E73421}"/>
              </a:ext>
            </a:extLst>
          </p:cNvPr>
          <p:cNvSpPr txBox="1"/>
          <p:nvPr/>
        </p:nvSpPr>
        <p:spPr>
          <a:xfrm>
            <a:off x="5263904" y="3624863"/>
            <a:ext cx="3103247" cy="113877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700" dirty="0">
                <a:solidFill>
                  <a:srgbClr val="0065AA"/>
                </a:solidFill>
              </a:rPr>
              <a:t>Early elevated lactate level in peripheral artery gas was the independent risk factors for oliguria(1.19-fold odds)</a:t>
            </a:r>
            <a:endParaRPr lang="zh-CN" altLang="en-US" sz="1700" dirty="0"/>
          </a:p>
        </p:txBody>
      </p:sp>
      <p:sp>
        <p:nvSpPr>
          <p:cNvPr id="43" name="Rectangle 48">
            <a:extLst>
              <a:ext uri="{FF2B5EF4-FFF2-40B4-BE49-F238E27FC236}">
                <a16:creationId xmlns:a16="http://schemas.microsoft.com/office/drawing/2014/main" id="{D2158681-1F58-4860-13CB-E4BBCE67D0C8}"/>
              </a:ext>
            </a:extLst>
          </p:cNvPr>
          <p:cNvSpPr/>
          <p:nvPr/>
        </p:nvSpPr>
        <p:spPr>
          <a:xfrm>
            <a:off x="5012842" y="3042008"/>
            <a:ext cx="3385423" cy="569189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4" name="Up Arrow 69">
            <a:extLst>
              <a:ext uri="{FF2B5EF4-FFF2-40B4-BE49-F238E27FC236}">
                <a16:creationId xmlns:a16="http://schemas.microsoft.com/office/drawing/2014/main" id="{9F1BADD6-E920-BF80-957D-716412784CAE}"/>
              </a:ext>
            </a:extLst>
          </p:cNvPr>
          <p:cNvSpPr/>
          <p:nvPr/>
        </p:nvSpPr>
        <p:spPr>
          <a:xfrm rot="10800000">
            <a:off x="5095402" y="3023347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5" name="矩形 19">
            <a:extLst>
              <a:ext uri="{FF2B5EF4-FFF2-40B4-BE49-F238E27FC236}">
                <a16:creationId xmlns:a16="http://schemas.microsoft.com/office/drawing/2014/main" id="{5E3247CE-F464-FEBD-2155-1752B20C3F34}"/>
              </a:ext>
            </a:extLst>
          </p:cNvPr>
          <p:cNvSpPr/>
          <p:nvPr/>
        </p:nvSpPr>
        <p:spPr>
          <a:xfrm>
            <a:off x="5383447" y="3180916"/>
            <a:ext cx="2975071" cy="3539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700" dirty="0">
                <a:solidFill>
                  <a:srgbClr val="0065AA"/>
                </a:solidFill>
              </a:rPr>
              <a:t>Lower urinary volume, UOP</a:t>
            </a:r>
            <a:endParaRPr lang="zh-CN" altLang="en-US" sz="1700" dirty="0">
              <a:solidFill>
                <a:srgbClr val="0065AA"/>
              </a:solidFill>
            </a:endParaRPr>
          </a:p>
        </p:txBody>
      </p:sp>
      <p:sp>
        <p:nvSpPr>
          <p:cNvPr id="46" name="Rectangle 48">
            <a:extLst>
              <a:ext uri="{FF2B5EF4-FFF2-40B4-BE49-F238E27FC236}">
                <a16:creationId xmlns:a16="http://schemas.microsoft.com/office/drawing/2014/main" id="{4CA59ADF-AE64-D4E2-D4CC-C447B1F4252E}"/>
              </a:ext>
            </a:extLst>
          </p:cNvPr>
          <p:cNvSpPr/>
          <p:nvPr/>
        </p:nvSpPr>
        <p:spPr>
          <a:xfrm>
            <a:off x="5012842" y="3679547"/>
            <a:ext cx="3385423" cy="1867649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7" name="文本框 33">
            <a:extLst>
              <a:ext uri="{FF2B5EF4-FFF2-40B4-BE49-F238E27FC236}">
                <a16:creationId xmlns:a16="http://schemas.microsoft.com/office/drawing/2014/main" id="{C00032B2-C8D9-8761-B345-1F4BADC3FDC7}"/>
              </a:ext>
            </a:extLst>
          </p:cNvPr>
          <p:cNvSpPr txBox="1"/>
          <p:nvPr/>
        </p:nvSpPr>
        <p:spPr>
          <a:xfrm>
            <a:off x="5246089" y="4707829"/>
            <a:ext cx="3112429" cy="8771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700" dirty="0">
                <a:solidFill>
                  <a:srgbClr val="0065AA"/>
                </a:solidFill>
              </a:rPr>
              <a:t>elevated lactate level exhibited a moderate predictive value (AUC = 0.62) for oliguria</a:t>
            </a:r>
            <a:endParaRPr lang="zh-CN" altLang="en-US" sz="1700" dirty="0">
              <a:solidFill>
                <a:srgbClr val="0065AA"/>
              </a:solidFill>
            </a:endParaRPr>
          </a:p>
        </p:txBody>
      </p:sp>
      <p:sp>
        <p:nvSpPr>
          <p:cNvPr id="48" name="椭圆 34">
            <a:extLst>
              <a:ext uri="{FF2B5EF4-FFF2-40B4-BE49-F238E27FC236}">
                <a16:creationId xmlns:a16="http://schemas.microsoft.com/office/drawing/2014/main" id="{4299E080-C6D7-311C-D0CD-990229A592EF}"/>
              </a:ext>
            </a:extLst>
          </p:cNvPr>
          <p:cNvSpPr/>
          <p:nvPr/>
        </p:nvSpPr>
        <p:spPr>
          <a:xfrm>
            <a:off x="5077624" y="3745222"/>
            <a:ext cx="186280" cy="181584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椭圆 37">
            <a:extLst>
              <a:ext uri="{FF2B5EF4-FFF2-40B4-BE49-F238E27FC236}">
                <a16:creationId xmlns:a16="http://schemas.microsoft.com/office/drawing/2014/main" id="{63A8620E-3E86-ABF8-012C-B31F30B87969}"/>
              </a:ext>
            </a:extLst>
          </p:cNvPr>
          <p:cNvSpPr/>
          <p:nvPr/>
        </p:nvSpPr>
        <p:spPr>
          <a:xfrm>
            <a:off x="5097577" y="4841368"/>
            <a:ext cx="186280" cy="181584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0" name="图片 43">
            <a:extLst>
              <a:ext uri="{FF2B5EF4-FFF2-40B4-BE49-F238E27FC236}">
                <a16:creationId xmlns:a16="http://schemas.microsoft.com/office/drawing/2014/main" id="{FE5345ED-96D7-9A5D-33D9-E2B3EE3DC3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6" t="4373" r="6118" b="5649"/>
          <a:stretch/>
        </p:blipFill>
        <p:spPr>
          <a:xfrm>
            <a:off x="8722756" y="1981221"/>
            <a:ext cx="3385423" cy="3459694"/>
          </a:xfrm>
          <a:prstGeom prst="rect">
            <a:avLst/>
          </a:prstGeom>
        </p:spPr>
      </p:pic>
      <p:sp>
        <p:nvSpPr>
          <p:cNvPr id="51" name="文本框 2">
            <a:extLst>
              <a:ext uri="{FF2B5EF4-FFF2-40B4-BE49-F238E27FC236}">
                <a16:creationId xmlns:a16="http://schemas.microsoft.com/office/drawing/2014/main" id="{515E0ECD-D8D4-6CC5-2D3A-92C18022CFB9}"/>
              </a:ext>
            </a:extLst>
          </p:cNvPr>
          <p:cNvSpPr txBox="1"/>
          <p:nvPr/>
        </p:nvSpPr>
        <p:spPr>
          <a:xfrm>
            <a:off x="466893" y="1586138"/>
            <a:ext cx="4005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altLang="zh-CN" dirty="0">
                <a:solidFill>
                  <a:srgbClr val="0065AA"/>
                </a:solidFill>
              </a:rPr>
              <a:t>Retrospective study in a Level III NICU</a:t>
            </a:r>
            <a:endParaRPr lang="zh-CN" altLang="en-US" dirty="0"/>
          </a:p>
        </p:txBody>
      </p:sp>
      <p:sp>
        <p:nvSpPr>
          <p:cNvPr id="52" name="矩形 38">
            <a:extLst>
              <a:ext uri="{FF2B5EF4-FFF2-40B4-BE49-F238E27FC236}">
                <a16:creationId xmlns:a16="http://schemas.microsoft.com/office/drawing/2014/main" id="{71F20927-0EBC-0E96-63AB-5156CB3514F1}"/>
              </a:ext>
            </a:extLst>
          </p:cNvPr>
          <p:cNvSpPr/>
          <p:nvPr/>
        </p:nvSpPr>
        <p:spPr>
          <a:xfrm>
            <a:off x="4874959" y="1571608"/>
            <a:ext cx="437703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zh-CN" dirty="0">
                <a:solidFill>
                  <a:srgbClr val="0065AA"/>
                </a:solidFill>
              </a:rPr>
              <a:t>Asphyxiated term neonates in oliguria group:</a:t>
            </a:r>
            <a:endParaRPr lang="en-US" altLang="zh-CN" baseline="30000" dirty="0">
              <a:solidFill>
                <a:srgbClr val="0065AA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29</TotalTime>
  <Words>194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2-15T16:20:52Z</dcterms:modified>
</cp:coreProperties>
</file>